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6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C71BD79-2227-4439-A96E-598F28FD6F9C}" v="446" dt="2024-02-27T15:03:41.33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77914" autoAdjust="0"/>
  </p:normalViewPr>
  <p:slideViewPr>
    <p:cSldViewPr>
      <p:cViewPr>
        <p:scale>
          <a:sx n="150" d="100"/>
          <a:sy n="150" d="100"/>
        </p:scale>
        <p:origin x="1044" y="-34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7E9D84-612E-4CF5-BB1E-4C3DF8BE2B79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98CBC0-CF9D-4C2D-8CB6-AE02C01A58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32745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arenR"/>
            </a:pPr>
            <a:endParaRPr lang="en-GB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98CBC0-CF9D-4C2D-8CB6-AE02C01A58A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23530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7574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5386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4222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3010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0426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3508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421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7694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9028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3264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8308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40233-4DD6-46C7-AC64-BF0F80889A4E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AF94F-992A-4E66-B219-9AF2A62309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9691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13661" y="281364"/>
            <a:ext cx="3281760" cy="3078878"/>
            <a:chOff x="404664" y="1403648"/>
            <a:chExt cx="3456384" cy="3158253"/>
          </a:xfrm>
        </p:grpSpPr>
        <p:pic>
          <p:nvPicPr>
            <p:cNvPr id="70" name="Picture 6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73" r="32288"/>
            <a:stretch/>
          </p:blipFill>
          <p:spPr>
            <a:xfrm>
              <a:off x="404664" y="1403648"/>
              <a:ext cx="3456384" cy="3158253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138" b="86401"/>
            <a:stretch/>
          </p:blipFill>
          <p:spPr>
            <a:xfrm>
              <a:off x="1340604" y="1596781"/>
              <a:ext cx="1728520" cy="441728"/>
            </a:xfrm>
            <a:prstGeom prst="rect">
              <a:avLst/>
            </a:prstGeom>
          </p:spPr>
        </p:pic>
      </p:grpSp>
      <p:sp>
        <p:nvSpPr>
          <p:cNvPr id="12" name="Text Box 135"/>
          <p:cNvSpPr txBox="1"/>
          <p:nvPr/>
        </p:nvSpPr>
        <p:spPr>
          <a:xfrm>
            <a:off x="94148" y="160665"/>
            <a:ext cx="258445" cy="43243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latin typeface="Calibri"/>
                <a:ea typeface="MS Mincho"/>
                <a:cs typeface="Times New Roman"/>
              </a:rPr>
              <a:t>A</a:t>
            </a:r>
            <a:endParaRPr lang="en-GB" sz="1400" dirty="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sp>
        <p:nvSpPr>
          <p:cNvPr id="13" name="Text Box 138"/>
          <p:cNvSpPr txBox="1"/>
          <p:nvPr/>
        </p:nvSpPr>
        <p:spPr>
          <a:xfrm>
            <a:off x="3870269" y="157807"/>
            <a:ext cx="264795" cy="42735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latin typeface="Calibri"/>
                <a:ea typeface="MS Mincho"/>
                <a:cs typeface="Times New Roman"/>
              </a:rPr>
              <a:t>B</a:t>
            </a:r>
            <a:endParaRPr lang="en-GB" sz="1400" dirty="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sp>
        <p:nvSpPr>
          <p:cNvPr id="15" name="Text Box 99"/>
          <p:cNvSpPr txBox="1"/>
          <p:nvPr/>
        </p:nvSpPr>
        <p:spPr>
          <a:xfrm>
            <a:off x="125222" y="4117087"/>
            <a:ext cx="291465" cy="38290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latin typeface="Calibri"/>
                <a:ea typeface="MS Mincho"/>
                <a:cs typeface="Times New Roman"/>
              </a:rPr>
              <a:t>C</a:t>
            </a:r>
            <a:endParaRPr lang="en-GB" sz="1400" dirty="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grpSp>
        <p:nvGrpSpPr>
          <p:cNvPr id="71" name="Group 70"/>
          <p:cNvGrpSpPr/>
          <p:nvPr/>
        </p:nvGrpSpPr>
        <p:grpSpPr>
          <a:xfrm>
            <a:off x="349794" y="3536074"/>
            <a:ext cx="2517760" cy="3124158"/>
            <a:chOff x="674264" y="2432494"/>
            <a:chExt cx="4479660" cy="6159951"/>
          </a:xfrm>
        </p:grpSpPr>
        <p:pic>
          <p:nvPicPr>
            <p:cNvPr id="72" name="Picture 7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411" t="36519" r="136" b="31494"/>
            <a:stretch/>
          </p:blipFill>
          <p:spPr>
            <a:xfrm>
              <a:off x="1905809" y="6622771"/>
              <a:ext cx="2436148" cy="680689"/>
            </a:xfrm>
            <a:prstGeom prst="rect">
              <a:avLst/>
            </a:prstGeom>
          </p:spPr>
        </p:pic>
        <p:pic>
          <p:nvPicPr>
            <p:cNvPr id="73" name="Picture 72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24" t="36292" r="-32" b="30941"/>
            <a:stretch/>
          </p:blipFill>
          <p:spPr>
            <a:xfrm>
              <a:off x="1914619" y="7263772"/>
              <a:ext cx="2434842" cy="697060"/>
            </a:xfrm>
            <a:prstGeom prst="rect">
              <a:avLst/>
            </a:prstGeom>
          </p:spPr>
        </p:pic>
        <p:pic>
          <p:nvPicPr>
            <p:cNvPr id="74" name="Picture 7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67" t="36884" r="179" b="31289"/>
            <a:stretch/>
          </p:blipFill>
          <p:spPr>
            <a:xfrm>
              <a:off x="1918561" y="7912202"/>
              <a:ext cx="2439709" cy="680243"/>
            </a:xfrm>
            <a:prstGeom prst="rect">
              <a:avLst/>
            </a:prstGeom>
          </p:spPr>
        </p:pic>
        <p:pic>
          <p:nvPicPr>
            <p:cNvPr id="75" name="Picture 74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465" t="37158" r="-93" b="31271"/>
            <a:stretch/>
          </p:blipFill>
          <p:spPr>
            <a:xfrm>
              <a:off x="1902239" y="4594899"/>
              <a:ext cx="2439712" cy="670921"/>
            </a:xfrm>
            <a:prstGeom prst="rect">
              <a:avLst/>
            </a:prstGeom>
          </p:spPr>
        </p:pic>
        <p:pic>
          <p:nvPicPr>
            <p:cNvPr id="76" name="Picture 75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823" r="807" b="30575"/>
            <a:stretch/>
          </p:blipFill>
          <p:spPr>
            <a:xfrm>
              <a:off x="1910585" y="5246097"/>
              <a:ext cx="2439712" cy="723932"/>
            </a:xfrm>
            <a:prstGeom prst="rect">
              <a:avLst/>
            </a:prstGeom>
          </p:spPr>
        </p:pic>
        <p:pic>
          <p:nvPicPr>
            <p:cNvPr id="77" name="Picture 76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" t="37244" r="973" b="31193"/>
            <a:stretch/>
          </p:blipFill>
          <p:spPr>
            <a:xfrm>
              <a:off x="1914718" y="5953739"/>
              <a:ext cx="2439709" cy="681683"/>
            </a:xfrm>
            <a:prstGeom prst="rect">
              <a:avLst/>
            </a:prstGeom>
          </p:spPr>
        </p:pic>
        <p:pic>
          <p:nvPicPr>
            <p:cNvPr id="78" name="Picture 77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" t="37452" r="163" b="32088"/>
            <a:stretch/>
          </p:blipFill>
          <p:spPr>
            <a:xfrm>
              <a:off x="1902254" y="3358512"/>
              <a:ext cx="2439710" cy="653054"/>
            </a:xfrm>
            <a:prstGeom prst="rect">
              <a:avLst/>
            </a:prstGeom>
          </p:spPr>
        </p:pic>
        <p:sp>
          <p:nvSpPr>
            <p:cNvPr id="79" name="TextBox 78"/>
            <p:cNvSpPr txBox="1"/>
            <p:nvPr/>
          </p:nvSpPr>
          <p:spPr>
            <a:xfrm rot="19352339">
              <a:off x="1920281" y="2878752"/>
              <a:ext cx="765741" cy="283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err="1"/>
                <a:t>siSCR</a:t>
              </a:r>
              <a:r>
                <a:rPr lang="en-GB" sz="800" dirty="0"/>
                <a:t> 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 rot="19165576">
              <a:off x="2500395" y="2806319"/>
              <a:ext cx="952974" cy="283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err="1"/>
                <a:t>siSLUG</a:t>
              </a:r>
              <a:endParaRPr lang="en-GB" sz="800" dirty="0"/>
            </a:p>
          </p:txBody>
        </p:sp>
        <p:sp>
          <p:nvSpPr>
            <p:cNvPr id="81" name="TextBox 80"/>
            <p:cNvSpPr txBox="1"/>
            <p:nvPr/>
          </p:nvSpPr>
          <p:spPr>
            <a:xfrm rot="18913958">
              <a:off x="3149608" y="2858412"/>
              <a:ext cx="892013" cy="283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err="1"/>
                <a:t>siSNAIL</a:t>
              </a:r>
              <a:r>
                <a:rPr lang="en-GB" sz="800" dirty="0"/>
                <a:t> 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1279243" y="3436343"/>
              <a:ext cx="1195220" cy="283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MCF7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929302" y="5346055"/>
              <a:ext cx="1069461" cy="283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HCC-1806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674264" y="4694266"/>
              <a:ext cx="1539787" cy="4247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MDA-MB-468 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956050" y="6021460"/>
              <a:ext cx="1151311" cy="283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HCC-3153  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692341" y="8032460"/>
              <a:ext cx="1370317" cy="283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MDA-MB-231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169303" y="7348480"/>
              <a:ext cx="875277" cy="424794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GB" sz="800" dirty="0"/>
                <a:t>Hs578T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674264" y="6733732"/>
              <a:ext cx="1370315" cy="4247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MDA-MB-436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1324139" y="4164531"/>
              <a:ext cx="781573" cy="283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T47D</a:t>
              </a:r>
              <a:endParaRPr lang="en-GB" sz="800" dirty="0"/>
            </a:p>
          </p:txBody>
        </p:sp>
        <p:sp>
          <p:nvSpPr>
            <p:cNvPr id="91" name="TextBox 90"/>
            <p:cNvSpPr txBox="1"/>
            <p:nvPr/>
          </p:nvSpPr>
          <p:spPr>
            <a:xfrm rot="18913958">
              <a:off x="3747310" y="2432494"/>
              <a:ext cx="1406614" cy="6675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err="1"/>
                <a:t>siSLUG</a:t>
              </a:r>
              <a:r>
                <a:rPr lang="en-GB" sz="800" dirty="0"/>
                <a:t>, </a:t>
              </a:r>
              <a:r>
                <a:rPr lang="en-GB" sz="800" dirty="0" err="1"/>
                <a:t>siSNAIL</a:t>
              </a:r>
              <a:r>
                <a:rPr lang="en-GB" sz="800" dirty="0"/>
                <a:t> </a:t>
              </a:r>
            </a:p>
          </p:txBody>
        </p:sp>
        <p:pic>
          <p:nvPicPr>
            <p:cNvPr id="92" name="Picture 91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6949" b="32610"/>
            <a:stretch/>
          </p:blipFill>
          <p:spPr>
            <a:xfrm>
              <a:off x="1902245" y="3957473"/>
              <a:ext cx="2439712" cy="651957"/>
            </a:xfrm>
            <a:prstGeom prst="rect">
              <a:avLst/>
            </a:prstGeom>
          </p:spPr>
        </p:pic>
      </p:grpSp>
      <p:pic>
        <p:nvPicPr>
          <p:cNvPr id="69" name="Picture 68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754"/>
          <a:stretch/>
        </p:blipFill>
        <p:spPr>
          <a:xfrm>
            <a:off x="4252084" y="5883"/>
            <a:ext cx="1809749" cy="3611978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3F4BD942-9502-AC14-E30A-22FC110BA043}"/>
              </a:ext>
            </a:extLst>
          </p:cNvPr>
          <p:cNvSpPr txBox="1"/>
          <p:nvPr/>
        </p:nvSpPr>
        <p:spPr>
          <a:xfrm>
            <a:off x="44624" y="6877997"/>
            <a:ext cx="6329330" cy="1754326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GB" sz="1200" b="1" kern="100" dirty="0">
                <a:effectLst/>
                <a:latin typeface="Calibri"/>
                <a:ea typeface="Calibri"/>
                <a:cs typeface="Times New Roman"/>
              </a:rPr>
              <a:t>Supplementary Figure S2. Snai2 expression correlates with poor-outcome in </a:t>
            </a:r>
            <a:r>
              <a:rPr lang="en-GB" sz="1200" b="1" kern="100" dirty="0">
                <a:latin typeface="Calibri"/>
                <a:ea typeface="Calibri"/>
                <a:cs typeface="Times New Roman"/>
              </a:rPr>
              <a:t>primary breast cancers </a:t>
            </a:r>
            <a:r>
              <a:rPr lang="en-GB" sz="1200" b="1" kern="100" dirty="0">
                <a:effectLst/>
                <a:latin typeface="Calibri"/>
                <a:ea typeface="Calibri"/>
                <a:cs typeface="Times New Roman"/>
              </a:rPr>
              <a:t>and </a:t>
            </a:r>
            <a:r>
              <a:rPr lang="en-GB" sz="1200" b="1" kern="100" dirty="0">
                <a:latin typeface="Calibri"/>
                <a:ea typeface="Calibri"/>
                <a:cs typeface="Times New Roman"/>
              </a:rPr>
              <a:t>a survival factor in</a:t>
            </a:r>
            <a:r>
              <a:rPr lang="en-GB" sz="1200" b="1" kern="100" dirty="0"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GB" sz="1200" b="1" kern="100" dirty="0">
                <a:latin typeface="Calibri"/>
                <a:ea typeface="Calibri"/>
                <a:cs typeface="Times New Roman"/>
              </a:rPr>
              <a:t>multiple breast</a:t>
            </a:r>
            <a:r>
              <a:rPr lang="en-GB" sz="1200" b="1" kern="100" dirty="0">
                <a:effectLst/>
                <a:latin typeface="Calibri"/>
                <a:ea typeface="Calibri"/>
                <a:cs typeface="Times New Roman"/>
              </a:rPr>
              <a:t> cancer cell lines.  </a:t>
            </a:r>
            <a:endParaRPr lang="en-DE" sz="1200" kern="100" dirty="0">
              <a:effectLst/>
              <a:latin typeface="Calibri"/>
              <a:ea typeface="Calibri"/>
              <a:cs typeface="Times New Roman"/>
            </a:endParaRPr>
          </a:p>
          <a:p>
            <a:r>
              <a:rPr lang="en-GB" sz="1200" b="1" kern="100" dirty="0">
                <a:latin typeface="Calibri"/>
                <a:ea typeface="Calibri"/>
                <a:cs typeface="Times New Roman"/>
              </a:rPr>
              <a:t>A: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 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Kaplan-Meier curves 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showing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 survival outcomes in Invasive Breast 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Cancers,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 stratified by 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SLUG (SNAI2)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 high expression (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EXPR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&gt;2)(</a:t>
            </a:r>
            <a:r>
              <a:rPr lang="en-GB" sz="1200" kern="100" dirty="0" err="1">
                <a:effectLst/>
                <a:latin typeface="Calibri"/>
                <a:ea typeface="Calibri"/>
                <a:cs typeface="Times New Roman"/>
              </a:rPr>
              <a:t>cBioPortal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 analysis of </a:t>
            </a:r>
            <a:r>
              <a:rPr lang="en-GB" sz="1200" kern="100" dirty="0" err="1">
                <a:effectLst/>
                <a:latin typeface="Calibri"/>
                <a:ea typeface="Calibri"/>
                <a:cs typeface="Times New Roman"/>
              </a:rPr>
              <a:t>Metabric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 data).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 </a:t>
            </a:r>
            <a:r>
              <a:rPr lang="en-GB" sz="1200" b="1" kern="100" dirty="0">
                <a:latin typeface="Calibri"/>
                <a:ea typeface="Calibri"/>
                <a:cs typeface="Times New Roman"/>
              </a:rPr>
              <a:t>B: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 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Stacked bar graph representing breast cancer subtypes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,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 stratified by levels of 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SLUG (SNAI2)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 (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EXPR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&gt;2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), showing that the claudin-low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 subtype 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is enriched for higher levels of SLUG expression 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(</a:t>
            </a:r>
            <a:r>
              <a:rPr lang="en-GB" sz="1200" kern="100" dirty="0" err="1">
                <a:effectLst/>
                <a:latin typeface="Calibri"/>
                <a:ea typeface="Calibri"/>
                <a:cs typeface="Times New Roman"/>
              </a:rPr>
              <a:t>cBioPortal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 analysis of </a:t>
            </a:r>
            <a:r>
              <a:rPr lang="en-GB" sz="1200" kern="100" dirty="0" err="1">
                <a:effectLst/>
                <a:latin typeface="Calibri"/>
                <a:ea typeface="Calibri"/>
                <a:cs typeface="Times New Roman"/>
              </a:rPr>
              <a:t>Metabric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 data).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 </a:t>
            </a:r>
            <a:r>
              <a:rPr lang="en-GB" sz="1200" b="1" kern="100" dirty="0">
                <a:latin typeface="Calibri"/>
                <a:ea typeface="Calibri"/>
                <a:cs typeface="Times New Roman"/>
              </a:rPr>
              <a:t>C: 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Images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 of 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clonogenic assays of 8 different breast cancer cell lines, following siRNA mediated knockdown of SLUG, SNAIL, or SLUG and SNAIL, with colonies stained with crystal</a:t>
            </a:r>
            <a:r>
              <a:rPr lang="en-GB" sz="1200" kern="100" dirty="0">
                <a:effectLst/>
                <a:latin typeface="Calibri"/>
                <a:ea typeface="Calibri"/>
                <a:cs typeface="Times New Roman"/>
              </a:rPr>
              <a:t> violet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.</a:t>
            </a:r>
            <a:endParaRPr lang="en-DE" sz="1200" kern="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30EA076-E200-1C63-AC9F-771A8778D01B}"/>
              </a:ext>
            </a:extLst>
          </p:cNvPr>
          <p:cNvSpPr txBox="1"/>
          <p:nvPr/>
        </p:nvSpPr>
        <p:spPr>
          <a:xfrm rot="16200000">
            <a:off x="3668052" y="1466427"/>
            <a:ext cx="1444626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sz="800" b="1" dirty="0"/>
              <a:t>Pam50 + Claudin-low subtype</a:t>
            </a:r>
          </a:p>
          <a:p>
            <a:pPr algn="ctr"/>
            <a:r>
              <a:rPr lang="en-GB" sz="800" b="1" dirty="0"/>
              <a:t># samples (%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01EF175-A804-E517-CCDD-0CC0FFD40CBF}"/>
              </a:ext>
            </a:extLst>
          </p:cNvPr>
          <p:cNvSpPr txBox="1"/>
          <p:nvPr/>
        </p:nvSpPr>
        <p:spPr>
          <a:xfrm>
            <a:off x="542092" y="3060478"/>
            <a:ext cx="75533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800" b="1" dirty="0"/>
              <a:t>SNAI2: EXP&gt;2</a:t>
            </a:r>
          </a:p>
          <a:p>
            <a:r>
              <a:rPr lang="en-GB" sz="800" b="1" dirty="0"/>
              <a:t>SNAI2: EXP&lt;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3FF13D0-E2D9-5B53-8A1B-029A23C50E05}"/>
              </a:ext>
            </a:extLst>
          </p:cNvPr>
          <p:cNvSpPr txBox="1"/>
          <p:nvPr/>
        </p:nvSpPr>
        <p:spPr>
          <a:xfrm rot="3080245">
            <a:off x="4687059" y="3256878"/>
            <a:ext cx="74865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b="1" dirty="0"/>
              <a:t>SNAI2: EXP&lt;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F4AD595-0711-AA38-40D9-60D25BBA4771}"/>
              </a:ext>
            </a:extLst>
          </p:cNvPr>
          <p:cNvSpPr txBox="1"/>
          <p:nvPr/>
        </p:nvSpPr>
        <p:spPr>
          <a:xfrm rot="3040330">
            <a:off x="4887400" y="3266035"/>
            <a:ext cx="74865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b="1" dirty="0"/>
              <a:t>SNAI2: EXP&gt;2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34C6ECE5-1B6A-CDF5-B153-BD6DE6166044}"/>
              </a:ext>
            </a:extLst>
          </p:cNvPr>
          <p:cNvGrpSpPr/>
          <p:nvPr/>
        </p:nvGrpSpPr>
        <p:grpSpPr>
          <a:xfrm>
            <a:off x="5541097" y="632044"/>
            <a:ext cx="1146629" cy="1412074"/>
            <a:chOff x="5541097" y="632044"/>
            <a:chExt cx="1146629" cy="1412074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B75AE23-1F8D-7E1A-2AD5-F4B8BAB4A19B}"/>
                </a:ext>
              </a:extLst>
            </p:cNvPr>
            <p:cNvSpPr txBox="1"/>
            <p:nvPr/>
          </p:nvSpPr>
          <p:spPr>
            <a:xfrm>
              <a:off x="5541097" y="632044"/>
              <a:ext cx="46519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Basal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325A68D-0C04-F487-F525-005A60FFE349}"/>
                </a:ext>
              </a:extLst>
            </p:cNvPr>
            <p:cNvSpPr txBox="1"/>
            <p:nvPr/>
          </p:nvSpPr>
          <p:spPr>
            <a:xfrm>
              <a:off x="5555685" y="825446"/>
              <a:ext cx="90120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Her2-positive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E836BFE-8CF0-EC8B-9CF2-FB587D66C139}"/>
                </a:ext>
              </a:extLst>
            </p:cNvPr>
            <p:cNvSpPr txBox="1"/>
            <p:nvPr/>
          </p:nvSpPr>
          <p:spPr>
            <a:xfrm>
              <a:off x="5555685" y="1013575"/>
              <a:ext cx="71365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Luminal A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E025CA6-8FFD-04E2-6A7C-B7F1BB876F1F}"/>
                </a:ext>
              </a:extLst>
            </p:cNvPr>
            <p:cNvSpPr txBox="1"/>
            <p:nvPr/>
          </p:nvSpPr>
          <p:spPr>
            <a:xfrm>
              <a:off x="5546067" y="1236961"/>
              <a:ext cx="70884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Luminal 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08CEE4B-7A4F-92EF-F3B0-7C482BFC906E}"/>
                </a:ext>
              </a:extLst>
            </p:cNvPr>
            <p:cNvSpPr txBox="1"/>
            <p:nvPr/>
          </p:nvSpPr>
          <p:spPr>
            <a:xfrm>
              <a:off x="5546067" y="1414049"/>
              <a:ext cx="114165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Not Characterised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6AC2C6B-B8A5-0D41-28E2-589955FF6113}"/>
                </a:ext>
              </a:extLst>
            </p:cNvPr>
            <p:cNvSpPr txBox="1"/>
            <p:nvPr/>
          </p:nvSpPr>
          <p:spPr>
            <a:xfrm>
              <a:off x="5544194" y="1595332"/>
              <a:ext cx="58221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Normal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9D6755B-4087-BA4C-DD54-E2D52E54F9DA}"/>
                </a:ext>
              </a:extLst>
            </p:cNvPr>
            <p:cNvSpPr txBox="1"/>
            <p:nvPr/>
          </p:nvSpPr>
          <p:spPr>
            <a:xfrm>
              <a:off x="5552895" y="1797897"/>
              <a:ext cx="82105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Claudin-low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17588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E7D440C2D9FBC4F81ED99EE7412C334" ma:contentTypeVersion="12" ma:contentTypeDescription="Create a new document." ma:contentTypeScope="" ma:versionID="a4097d6fb1df5daf43bb6ca05d50f889">
  <xsd:schema xmlns:xsd="http://www.w3.org/2001/XMLSchema" xmlns:xs="http://www.w3.org/2001/XMLSchema" xmlns:p="http://schemas.microsoft.com/office/2006/metadata/properties" xmlns:ns3="19dc981f-0a43-4e2c-b226-00f9bfb5748e" xmlns:ns4="6b32de6a-ff42-479e-844c-8349c77529d7" targetNamespace="http://schemas.microsoft.com/office/2006/metadata/properties" ma:root="true" ma:fieldsID="723ab0db2e948b7a7da8adf5ad1423ca" ns3:_="" ns4:_="">
    <xsd:import namespace="19dc981f-0a43-4e2c-b226-00f9bfb5748e"/>
    <xsd:import namespace="6b32de6a-ff42-479e-844c-8349c77529d7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dc981f-0a43-4e2c-b226-00f9bfb5748e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b32de6a-ff42-479e-844c-8349c77529d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F60E94F3-2F9F-49EC-9A73-23BB9309EDD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9dc981f-0a43-4e2c-b226-00f9bfb5748e"/>
    <ds:schemaRef ds:uri="6b32de6a-ff42-479e-844c-8349c77529d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9DEEF1E-54EA-41DB-8ED7-ACCB28842A4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3EC3F74-141E-4376-8147-FE769D9A4934}">
  <ds:schemaRefs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  <ds:schemaRef ds:uri="http://schemas.microsoft.com/office/2006/documentManagement/types"/>
    <ds:schemaRef ds:uri="http://purl.org/dc/elements/1.1/"/>
    <ds:schemaRef ds:uri="19dc981f-0a43-4e2c-b226-00f9bfb5748e"/>
    <ds:schemaRef ds:uri="6b32de6a-ff42-479e-844c-8349c77529d7"/>
    <ds:schemaRef ds:uri="http://purl.org/dc/dcmitype/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88</Words>
  <Application>Microsoft Office PowerPoint</Application>
  <PresentationFormat>On-screen Show (4:3)</PresentationFormat>
  <Paragraphs>3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MS Mincho</vt:lpstr>
      <vt:lpstr>Arial</vt:lpstr>
      <vt:lpstr>Calibri</vt:lpstr>
      <vt:lpstr>Office Theme</vt:lpstr>
      <vt:lpstr>PowerPoint Presentation</vt:lpstr>
    </vt:vector>
  </TitlesOfParts>
  <Company>Medicine, Dentistry and Biomedical Scien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Paul Mullan</cp:lastModifiedBy>
  <cp:revision>136</cp:revision>
  <dcterms:created xsi:type="dcterms:W3CDTF">2017-08-17T14:06:28Z</dcterms:created>
  <dcterms:modified xsi:type="dcterms:W3CDTF">2024-07-23T09:58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E7D440C2D9FBC4F81ED99EE7412C334</vt:lpwstr>
  </property>
</Properties>
</file>